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80" r:id="rId2"/>
    <p:sldId id="281" r:id="rId3"/>
    <p:sldId id="282" r:id="rId4"/>
    <p:sldId id="283" r:id="rId5"/>
    <p:sldId id="256" r:id="rId6"/>
    <p:sldId id="257" r:id="rId7"/>
    <p:sldId id="258" r:id="rId8"/>
    <p:sldId id="278" r:id="rId9"/>
    <p:sldId id="277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721" autoAdjust="0"/>
    <p:restoredTop sz="94660"/>
  </p:normalViewPr>
  <p:slideViewPr>
    <p:cSldViewPr snapToGrid="0">
      <p:cViewPr varScale="1">
        <p:scale>
          <a:sx n="68" d="100"/>
          <a:sy n="68" d="100"/>
        </p:scale>
        <p:origin x="1116" y="60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444FCA-6E17-450C-ACE9-C65BE4296AA6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DD1717-4DA2-4E9A-BDFD-DA79447E2A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901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6313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027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8681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48601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1482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34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698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02136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6451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0354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821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B9FD0-A068-4521-9B22-C5DA41C90E42}" type="datetimeFigureOut">
              <a:rPr lang="zh-CN" altLang="en-US" smtClean="0"/>
              <a:t>2020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C19E2F-AE46-4443-886F-4D2C1A57B2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0682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HK" altLang="zh-CN" dirty="0"/>
              <a:t>Supplementary Material A. Search terms and search strategy used for PubMed</a:t>
            </a:r>
            <a:r>
              <a:rPr lang="zh-CN" altLang="zh-CN" dirty="0"/>
              <a:t/>
            </a:r>
            <a:br>
              <a:rPr lang="zh-CN" altLang="zh-CN" dirty="0"/>
            </a:b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38200" y="1509486"/>
            <a:ext cx="10515600" cy="5123543"/>
          </a:xfrm>
        </p:spPr>
        <p:txBody>
          <a:bodyPr>
            <a:normAutofit/>
          </a:bodyPr>
          <a:lstStyle/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1 (((((Immature platelet) OR (Reticulated platelets)) OR (IPF)) OR (IPC)) OR (Immature platelets fraction)) OR (Immature platelets count) OR (platelets turnover)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2 (((acute coronary syndrome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 OR (coronary artery disease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cardiovascular diseases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stable coronary artery disease)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3 ((acute coronary syndrome) OR (coronary artery disease)) OR (cardiovascular diseases)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4 #2 OR #3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5 </a:t>
            </a:r>
            <a:r>
              <a:rPr lang="en-HK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((((((cardiovascular 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th) OR (death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mortality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myocardial infarction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stroke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</a:t>
            </a:r>
            <a:r>
              <a:rPr lang="en-HK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ercutaneous Coronary Intervention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Myocardial Revascularization[</a:t>
            </a:r>
            <a:r>
              <a:rPr lang="en-HK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S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rms])) OR (Revascularization)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6 </a:t>
            </a:r>
            <a:r>
              <a:rPr lang="en-HK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(((((death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) OR (mortality)) OR (myocardial infarction)) OR (</a:t>
            </a:r>
            <a:r>
              <a:rPr lang="en-HK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roke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) 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HK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erebrovascular accidents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) </a:t>
            </a:r>
            <a:r>
              <a:rPr lang="en-HK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Percutaneous Coronary Intervention)) OR (Myocardial Revascularization)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7 #5 OR #6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HK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8 #1, #4 AND #7</a:t>
            </a:r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83442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HK" altLang="zh-CN" dirty="0"/>
              <a:t>Supplementary Material </a:t>
            </a:r>
            <a:r>
              <a:rPr lang="en-HK" altLang="zh-CN" dirty="0" smtClean="0"/>
              <a:t>B. </a:t>
            </a:r>
            <a:r>
              <a:rPr lang="en-HK" altLang="zh-CN" dirty="0"/>
              <a:t>Search terms and search strategy used for Web of Science</a:t>
            </a:r>
            <a:r>
              <a:rPr lang="zh-CN" altLang="zh-CN" dirty="0"/>
              <a:t/>
            </a:r>
            <a:br>
              <a:rPr lang="zh-CN" altLang="zh-CN" dirty="0"/>
            </a:b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38200" y="2090057"/>
            <a:ext cx="10515600" cy="5762171"/>
          </a:xfrm>
        </p:spPr>
        <p:txBody>
          <a:bodyPr>
            <a:normAutofit/>
          </a:bodyPr>
          <a:lstStyle/>
          <a:p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TS=(Reticulated platelets) OR TS=(Immature platelet) OR TS=(IPF) OR TS=(IPC) OR TS=(Immature platelet fraction) OR TS=(Immature platelet count) OR TS=(platelet turnover)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2 TS=(Coronary artery disease) OR TS=(Cardiovascular diseases) OR TS=( acute coronary syndrome) OR TS=( stable coronary artery disease)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3 TS=(Cardiovascular death) OR TS=(Mortality) OR TS=(Death) OR TS=(Myocardial infarction) OR TS=(Stroke) OR TS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=(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rebrovascular accidents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OR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S=(PCI) OR TS=(Revascularization) OR TS=(Percutaneous Coronary Intervention)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4 #1, #2 AND #3</a:t>
            </a:r>
          </a:p>
          <a:p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76598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HK" altLang="zh-CN" dirty="0"/>
              <a:t>Supplementary Material </a:t>
            </a:r>
            <a:r>
              <a:rPr lang="en-HK" altLang="zh-CN" dirty="0" smtClean="0"/>
              <a:t>C. </a:t>
            </a:r>
            <a:r>
              <a:rPr lang="en-HK" altLang="zh-CN" dirty="0"/>
              <a:t>Search terms and search strategy used for </a:t>
            </a:r>
            <a:r>
              <a:rPr lang="en-HK" altLang="zh-CN" dirty="0" smtClean="0"/>
              <a:t>Scopus</a:t>
            </a:r>
            <a:r>
              <a:rPr lang="zh-CN" altLang="zh-CN" dirty="0"/>
              <a:t/>
            </a:r>
            <a:br>
              <a:rPr lang="zh-CN" altLang="zh-CN" dirty="0"/>
            </a:b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38200" y="2090057"/>
            <a:ext cx="10515600" cy="5762171"/>
          </a:xfrm>
        </p:spPr>
        <p:txBody>
          <a:bodyPr>
            <a:normAutofit/>
          </a:bodyPr>
          <a:lstStyle/>
          <a:p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( ALL ( "Reticulated platelets"  OR  "Immature platelets fraction"  OR  "Immature platelets"  OR  "immature platelets count" ) )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2 ( ALL ( "cardiovascular disease"  OR  "coronary artery disease"  OR  "acute coronary syndrome"  OR  "stable coronary artery disease" ) )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3 ( ALL ( "cardiovascular death"  OR  "mortality"  OR  "death"  OR  "myocardial infarction" OR  "stroke" OR  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“cerebrovascular accidents" 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 "revascularization" OR  "myocardial infarction" ) )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4 #1, #2 AND #3</a:t>
            </a:r>
          </a:p>
          <a:p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566711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HK" altLang="zh-CN" dirty="0"/>
              <a:t>Supplementary Material D</a:t>
            </a:r>
            <a:r>
              <a:rPr lang="en-HK" altLang="zh-CN" dirty="0" smtClean="0"/>
              <a:t>. </a:t>
            </a:r>
            <a:r>
              <a:rPr lang="en-HK" altLang="zh-CN" dirty="0"/>
              <a:t>Search terms and search strategy used for </a:t>
            </a:r>
            <a:r>
              <a:rPr lang="en-HK" altLang="zh-CN" dirty="0" err="1"/>
              <a:t>Embase</a:t>
            </a:r>
            <a:r>
              <a:rPr lang="zh-CN" altLang="zh-CN" dirty="0"/>
              <a:t/>
            </a:r>
            <a:br>
              <a:rPr lang="zh-CN" altLang="zh-CN" dirty="0"/>
            </a:b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838200" y="2090057"/>
            <a:ext cx="10515600" cy="5762171"/>
          </a:xfrm>
        </p:spPr>
        <p:txBody>
          <a:bodyPr>
            <a:normAutofit/>
          </a:bodyPr>
          <a:lstStyle/>
          <a:p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‘reticulated platelets’ OR ‘Immature platelets count’ OR ‘Immature platelets fraction’ OR ‘platelets turnover’ 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2 ‘coronary artery disease’ OR ‘cardiovascular disease’ OR ‘acute coronary syndrome’ OR ‘stable coronary artery disease</a:t>
            </a:r>
            <a:r>
              <a:rPr lang="en-US" altLang="zh-CN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’</a:t>
            </a:r>
            <a:endParaRPr lang="en-US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3 'cardiovascular death' OR mortality OR death OR 'heart infarction' OR 'cerebrovascular accident' OR 'revascularization'/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revascularization OR 'percutaneous coronary intervention'/</a:t>
            </a:r>
            <a:r>
              <a:rPr lang="en-US" altLang="zh-CN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</a:t>
            </a:r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'percutaneous coronary intervention' </a:t>
            </a:r>
          </a:p>
          <a:p>
            <a:r>
              <a:rPr lang="en-US" altLang="zh-CN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4 #1, #2 AND #3</a:t>
            </a:r>
          </a:p>
          <a:p>
            <a:endParaRPr lang="zh-CN" altLang="zh-CN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046669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5874327"/>
            <a:ext cx="9144000" cy="422564"/>
          </a:xfrm>
        </p:spPr>
        <p:txBody>
          <a:bodyPr/>
          <a:lstStyle/>
          <a:p>
            <a:r>
              <a:rPr lang="en-US" altLang="zh-CN" dirty="0" smtClean="0"/>
              <a:t>Supplementary Figure 1. Funnel plot.</a:t>
            </a:r>
            <a:endParaRPr lang="zh-CN" altLang="en-US" dirty="0"/>
          </a:p>
        </p:txBody>
      </p:sp>
      <p:pic>
        <p:nvPicPr>
          <p:cNvPr id="5" name="图片 4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675249"/>
            <a:ext cx="8975187" cy="51990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8267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副标题 2"/>
          <p:cNvSpPr txBox="1">
            <a:spLocks/>
          </p:cNvSpPr>
          <p:nvPr/>
        </p:nvSpPr>
        <p:spPr>
          <a:xfrm>
            <a:off x="1524000" y="5874327"/>
            <a:ext cx="9144000" cy="422564"/>
          </a:xfrm>
          <a:prstGeom prst="rect">
            <a:avLst/>
          </a:prstGeom>
        </p:spPr>
        <p:txBody>
          <a:bodyPr vert="horz" lIns="91440" tIns="45720" rIns="91440" bIns="45720" rtlCol="0">
            <a:normAutofit fontScale="77500" lnSpcReduction="2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dirty="0" smtClean="0"/>
              <a:t>Supplementary Figure 2</a:t>
            </a:r>
            <a:r>
              <a:rPr lang="en-US" altLang="zh-CN" dirty="0"/>
              <a:t>. Adjusted funnel plot using trim and fill method.</a:t>
            </a:r>
            <a:endParaRPr lang="zh-CN" altLang="en-US" dirty="0"/>
          </a:p>
        </p:txBody>
      </p:sp>
      <p:pic>
        <p:nvPicPr>
          <p:cNvPr id="6" name="图片 5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03"/>
          <a:stretch/>
        </p:blipFill>
        <p:spPr>
          <a:xfrm>
            <a:off x="1524000" y="145143"/>
            <a:ext cx="9270609" cy="57291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28430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副标题 2"/>
          <p:cNvSpPr txBox="1">
            <a:spLocks/>
          </p:cNvSpPr>
          <p:nvPr/>
        </p:nvSpPr>
        <p:spPr>
          <a:xfrm>
            <a:off x="1524000" y="5874327"/>
            <a:ext cx="9144000" cy="422564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altLang="zh-CN" dirty="0" smtClean="0"/>
              <a:t>Supplementary Figure 3. Egger test.</a:t>
            </a:r>
            <a:endParaRPr lang="zh-CN" altLang="en-US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74"/>
          <a:stretch/>
        </p:blipFill>
        <p:spPr>
          <a:xfrm>
            <a:off x="1891665" y="-14068"/>
            <a:ext cx="8954526" cy="57398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24196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-1304865" y="1434377"/>
            <a:ext cx="22902514" cy="9835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0584379"/>
              </p:ext>
            </p:extLst>
          </p:nvPr>
        </p:nvGraphicFramePr>
        <p:xfrm>
          <a:off x="957944" y="1088572"/>
          <a:ext cx="10377714" cy="529771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27437">
                  <a:extLst>
                    <a:ext uri="{9D8B030D-6E8A-4147-A177-3AD203B41FA5}">
                      <a16:colId xmlns:a16="http://schemas.microsoft.com/office/drawing/2014/main" val="1283247559"/>
                    </a:ext>
                  </a:extLst>
                </a:gridCol>
                <a:gridCol w="1050641">
                  <a:extLst>
                    <a:ext uri="{9D8B030D-6E8A-4147-A177-3AD203B41FA5}">
                      <a16:colId xmlns:a16="http://schemas.microsoft.com/office/drawing/2014/main" val="806226081"/>
                    </a:ext>
                  </a:extLst>
                </a:gridCol>
                <a:gridCol w="892412">
                  <a:extLst>
                    <a:ext uri="{9D8B030D-6E8A-4147-A177-3AD203B41FA5}">
                      <a16:colId xmlns:a16="http://schemas.microsoft.com/office/drawing/2014/main" val="1524314063"/>
                    </a:ext>
                  </a:extLst>
                </a:gridCol>
                <a:gridCol w="1350222">
                  <a:extLst>
                    <a:ext uri="{9D8B030D-6E8A-4147-A177-3AD203B41FA5}">
                      <a16:colId xmlns:a16="http://schemas.microsoft.com/office/drawing/2014/main" val="557877464"/>
                    </a:ext>
                  </a:extLst>
                </a:gridCol>
                <a:gridCol w="1346002">
                  <a:extLst>
                    <a:ext uri="{9D8B030D-6E8A-4147-A177-3AD203B41FA5}">
                      <a16:colId xmlns:a16="http://schemas.microsoft.com/office/drawing/2014/main" val="1760479517"/>
                    </a:ext>
                  </a:extLst>
                </a:gridCol>
                <a:gridCol w="1202540">
                  <a:extLst>
                    <a:ext uri="{9D8B030D-6E8A-4147-A177-3AD203B41FA5}">
                      <a16:colId xmlns:a16="http://schemas.microsoft.com/office/drawing/2014/main" val="3553843290"/>
                    </a:ext>
                  </a:extLst>
                </a:gridCol>
                <a:gridCol w="1504230">
                  <a:extLst>
                    <a:ext uri="{9D8B030D-6E8A-4147-A177-3AD203B41FA5}">
                      <a16:colId xmlns:a16="http://schemas.microsoft.com/office/drawing/2014/main" val="2491215057"/>
                    </a:ext>
                  </a:extLst>
                </a:gridCol>
                <a:gridCol w="1504230">
                  <a:extLst>
                    <a:ext uri="{9D8B030D-6E8A-4147-A177-3AD203B41FA5}">
                      <a16:colId xmlns:a16="http://schemas.microsoft.com/office/drawing/2014/main" val="3864295035"/>
                    </a:ext>
                  </a:extLst>
                </a:gridCol>
              </a:tblGrid>
              <a:tr h="142950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ourc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participation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attrition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gnostic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tor measurement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utcome measurement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confounding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tistical analysis 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 reporting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verall quality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360873648"/>
                  </a:ext>
                </a:extLst>
              </a:tr>
              <a:tr h="57837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rl2019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858720897"/>
                  </a:ext>
                </a:extLst>
              </a:tr>
              <a:tr h="57837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brahim2014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427078383"/>
                  </a:ext>
                </a:extLst>
              </a:tr>
              <a:tr h="57837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ynhofer201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951762833"/>
                  </a:ext>
                </a:extLst>
              </a:tr>
              <a:tr h="57837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charre2019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2280399602"/>
                  </a:ext>
                </a:extLst>
              </a:tr>
              <a:tr h="57837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sari2013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3737020703"/>
                  </a:ext>
                </a:extLst>
              </a:tr>
              <a:tr h="976310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ópez-Jiméne2013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ow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erate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889754962"/>
                  </a:ext>
                </a:extLst>
              </a:tr>
            </a:tbl>
          </a:graphicData>
        </a:graphic>
      </p:graphicFrame>
      <p:sp>
        <p:nvSpPr>
          <p:cNvPr id="6" name="标题 1"/>
          <p:cNvSpPr>
            <a:spLocks noGrp="1"/>
          </p:cNvSpPr>
          <p:nvPr>
            <p:ph type="title"/>
          </p:nvPr>
        </p:nvSpPr>
        <p:spPr>
          <a:xfrm>
            <a:off x="324758" y="404226"/>
            <a:ext cx="11010900" cy="571500"/>
          </a:xfrm>
        </p:spPr>
        <p:txBody>
          <a:bodyPr>
            <a:noAutofit/>
          </a:bodyPr>
          <a:lstStyle/>
          <a:p>
            <a:r>
              <a:rPr lang="en-US" altLang="zh-CN" sz="2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Quality assessment for each included study, based on QUIPS checklists</a:t>
            </a:r>
            <a:r>
              <a:rPr lang="zh-CN" altLang="zh-CN" sz="2000" kern="100" dirty="0">
                <a:latin typeface="等线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zh-CN" altLang="zh-CN" sz="2000" kern="100" dirty="0">
                <a:latin typeface="等线" panose="02010600030101010101" pitchFamily="2" charset="-122"/>
                <a:cs typeface="Times New Roman" panose="02020603050405020304" pitchFamily="18" charset="0"/>
              </a:rPr>
            </a:b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4136276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内容占位符 6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45714252"/>
              </p:ext>
            </p:extLst>
          </p:nvPr>
        </p:nvGraphicFramePr>
        <p:xfrm>
          <a:off x="896258" y="546101"/>
          <a:ext cx="10203541" cy="602343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5336761">
                  <a:extLst>
                    <a:ext uri="{9D8B030D-6E8A-4147-A177-3AD203B41FA5}">
                      <a16:colId xmlns:a16="http://schemas.microsoft.com/office/drawing/2014/main" val="3185583350"/>
                    </a:ext>
                  </a:extLst>
                </a:gridCol>
                <a:gridCol w="1216695">
                  <a:extLst>
                    <a:ext uri="{9D8B030D-6E8A-4147-A177-3AD203B41FA5}">
                      <a16:colId xmlns:a16="http://schemas.microsoft.com/office/drawing/2014/main" val="2272028647"/>
                    </a:ext>
                  </a:extLst>
                </a:gridCol>
                <a:gridCol w="1216695">
                  <a:extLst>
                    <a:ext uri="{9D8B030D-6E8A-4147-A177-3AD203B41FA5}">
                      <a16:colId xmlns:a16="http://schemas.microsoft.com/office/drawing/2014/main" val="1628935152"/>
                    </a:ext>
                  </a:extLst>
                </a:gridCol>
                <a:gridCol w="1216695">
                  <a:extLst>
                    <a:ext uri="{9D8B030D-6E8A-4147-A177-3AD203B41FA5}">
                      <a16:colId xmlns:a16="http://schemas.microsoft.com/office/drawing/2014/main" val="1287241806"/>
                    </a:ext>
                  </a:extLst>
                </a:gridCol>
                <a:gridCol w="1216695">
                  <a:extLst>
                    <a:ext uri="{9D8B030D-6E8A-4147-A177-3AD203B41FA5}">
                      <a16:colId xmlns:a16="http://schemas.microsoft.com/office/drawing/2014/main" val="3688722814"/>
                    </a:ext>
                  </a:extLst>
                </a:gridCol>
              </a:tblGrid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% CI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5%CI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lu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3205997686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s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1398003033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 marL="152400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ual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1948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2.7044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49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09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1894530140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 marL="152400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ngl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06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3.2411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276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22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1728443205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92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340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25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48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3281536579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female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8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889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85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783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3016558753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DM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10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31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51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51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1121069336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smoking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59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5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40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40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2152047859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HT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73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43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9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13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2470344748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dyslipidemia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090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40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60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35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4270200382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ype of relative risk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0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.0583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19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918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48665584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lity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5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259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972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12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2716405035"/>
                  </a:ext>
                </a:extLst>
              </a:tr>
              <a:tr h="463341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of </a:t>
                      </a:r>
                      <a:r>
                        <a:rPr lang="en-US" sz="14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actors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284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427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 font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141</a:t>
                      </a:r>
                      <a:endParaRPr lang="zh-CN" sz="140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120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52**</a:t>
                      </a:r>
                      <a:endParaRPr lang="zh-CN" sz="14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5080" marR="5080" marT="5080" marB="0" anchor="ctr"/>
                </a:tc>
                <a:extLst>
                  <a:ext uri="{0D108BD9-81ED-4DB2-BD59-A6C34878D82A}">
                    <a16:rowId xmlns:a16="http://schemas.microsoft.com/office/drawing/2014/main" val="2904145008"/>
                  </a:ext>
                </a:extLst>
              </a:tr>
            </a:tbl>
          </a:graphicData>
        </a:graphic>
      </p:graphicFrame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-1304865" y="1434377"/>
            <a:ext cx="22902514" cy="9835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0" name="标题 1"/>
          <p:cNvSpPr>
            <a:spLocks noGrp="1"/>
          </p:cNvSpPr>
          <p:nvPr>
            <p:ph type="title"/>
          </p:nvPr>
        </p:nvSpPr>
        <p:spPr>
          <a:xfrm>
            <a:off x="792843" y="0"/>
            <a:ext cx="11010900" cy="571500"/>
          </a:xfrm>
        </p:spPr>
        <p:txBody>
          <a:bodyPr>
            <a:noAutofit/>
          </a:bodyPr>
          <a:lstStyle/>
          <a:p>
            <a:r>
              <a:rPr lang="en-US" altLang="zh-CN" sz="20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</a:t>
            </a:r>
            <a:r>
              <a:rPr lang="en-US" altLang="zh-CN" sz="2000" kern="1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. Detailed results of meta-regression</a:t>
            </a: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3076504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02</TotalTime>
  <Words>794</Words>
  <Application>Microsoft Office PowerPoint</Application>
  <PresentationFormat>宽屏</PresentationFormat>
  <Paragraphs>152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5" baseType="lpstr">
      <vt:lpstr>等线</vt:lpstr>
      <vt:lpstr>等线 Light</vt:lpstr>
      <vt:lpstr>宋体</vt:lpstr>
      <vt:lpstr>Arial</vt:lpstr>
      <vt:lpstr>Times New Roman</vt:lpstr>
      <vt:lpstr>Office 主题​​</vt:lpstr>
      <vt:lpstr>Supplementary Material A. Search terms and search strategy used for PubMed </vt:lpstr>
      <vt:lpstr>Supplementary Material B. Search terms and search strategy used for Web of Science </vt:lpstr>
      <vt:lpstr>Supplementary Material C. Search terms and search strategy used for Scopus </vt:lpstr>
      <vt:lpstr>Supplementary Material D. Search terms and search strategy used for Embase </vt:lpstr>
      <vt:lpstr>PowerPoint 演示文稿</vt:lpstr>
      <vt:lpstr>PowerPoint 演示文稿</vt:lpstr>
      <vt:lpstr>PowerPoint 演示文稿</vt:lpstr>
      <vt:lpstr>Supplementary Table 1. Quality assessment for each included study, based on QUIPS checklists </vt:lpstr>
      <vt:lpstr>Supplementary Table 2. Detailed results of meta-regress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锋</dc:creator>
  <cp:lastModifiedBy>x_x110</cp:lastModifiedBy>
  <cp:revision>36</cp:revision>
  <dcterms:created xsi:type="dcterms:W3CDTF">2019-12-24T02:42:23Z</dcterms:created>
  <dcterms:modified xsi:type="dcterms:W3CDTF">2020-09-06T04:37:35Z</dcterms:modified>
</cp:coreProperties>
</file>